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4955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9401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830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3993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525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81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68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1309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1507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1017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0969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B85C52-8A67-47FE-ABA6-C288B5FD015E}" type="datetimeFigureOut">
              <a:rPr lang="ko-KR" altLang="en-US" smtClean="0"/>
              <a:t>2023-07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035955-C2C7-4CD3-8FB4-10C2805CC6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068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0415"/>
          <a:stretch/>
        </p:blipFill>
        <p:spPr>
          <a:xfrm>
            <a:off x="3819392" y="1516133"/>
            <a:ext cx="3828288" cy="216618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883243" y="3912974"/>
            <a:ext cx="610423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 2. Kaplan-Meier graph depicting the overall survival after </a:t>
            </a:r>
            <a:r>
              <a:rPr lang="en-US" altLang="ko-KR" sz="11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amma Knife surgery (GKS) </a:t>
            </a:r>
            <a:r>
              <a:rPr lang="en-US" altLang="ko-KR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etween the groups with and without concurrent </a:t>
            </a:r>
            <a:r>
              <a:rPr lang="en-US" altLang="ko-KR" sz="11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argeted therapy or immunotherapy (TT/IT) </a:t>
            </a:r>
            <a:r>
              <a:rPr lang="en-US" altLang="ko-KR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ollowing GKS</a:t>
            </a:r>
            <a:endParaRPr lang="ko-KR" altLang="ko-KR" sz="11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890744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 Unicode MS</vt:lpstr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</cp:revision>
  <dcterms:created xsi:type="dcterms:W3CDTF">2023-07-04T09:20:46Z</dcterms:created>
  <dcterms:modified xsi:type="dcterms:W3CDTF">2023-07-04T09:20:58Z</dcterms:modified>
</cp:coreProperties>
</file>